
<file path=[Content_Types].xml><?xml version="1.0" encoding="utf-8"?>
<Types xmlns="http://schemas.openxmlformats.org/package/2006/content-types">
  <Default Extension="emf" ContentType="image/x-emf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  <p:sldId id="260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slideViewPr>
    <p:cSldViewPr snapToGrid="0">
      <p:cViewPr varScale="1">
        <p:scale>
          <a:sx n="66" d="100"/>
          <a:sy n="66" d="100"/>
        </p:scale>
        <p:origin x="0" y="0"/>
      </p:cViewPr>
      <p:guideLst/>
    </p:cSldViewPr>
  </p:slide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F0BA39A-7D5C-EEF8-6E76-36F7385CCD9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5D5BDF2-EBDC-D4F0-4D0D-E1A11DDC47A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D4BD2D8-5A08-DB02-648E-9D849AC7EC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3F52E9-2FF6-4390-917F-0BA6DE85BBA2}" type="datetimeFigureOut">
              <a:rPr lang="en-US" smtClean="0"/>
              <a:t>3/2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E2709C3-2810-81AC-3205-1724C2128F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1A1D756-968B-CF07-0E55-78ACE6A660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E9AE9E-BD05-4698-9ACB-30715FA44C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99900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DF487B5-BE4A-788F-1BF4-A0C3676078B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488A4F7-4AEE-F205-BFC7-7E1860F10D6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B20E418-C86B-014C-32FB-AAAF23E112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3F52E9-2FF6-4390-917F-0BA6DE85BBA2}" type="datetimeFigureOut">
              <a:rPr lang="en-US" smtClean="0"/>
              <a:t>3/2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7D34E7C-EF8E-1709-471C-572B46DCF6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7FC235D-FF33-4CC5-AA6D-1B6D6CDE77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E9AE9E-BD05-4698-9ACB-30715FA44C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56416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2E9B550-7CE6-5B44-FB86-8E4A656DA18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6F2222D-1EC0-B85F-4F62-B69F878865A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AF46B32-728C-3C04-02B5-26567FB280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3F52E9-2FF6-4390-917F-0BA6DE85BBA2}" type="datetimeFigureOut">
              <a:rPr lang="en-US" smtClean="0"/>
              <a:t>3/2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1C2DA56-DA19-FE07-DBA5-35B2343644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B2BE480-6A9F-6E7E-65CE-C9088509B1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E9AE9E-BD05-4698-9ACB-30715FA44C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38655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8FF2A8A-3973-A4A7-6E23-41172B3D85F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4AC22CF-1FCE-D33C-1D26-8B6AADF1C41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88133D5-669F-BD39-92F3-73DF2E8404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3F52E9-2FF6-4390-917F-0BA6DE85BBA2}" type="datetimeFigureOut">
              <a:rPr lang="en-US" smtClean="0"/>
              <a:t>3/2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ED213FF-E871-9973-1061-DC3DAFA845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52E33FB-ECD6-3486-FB98-9072505061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E9AE9E-BD05-4698-9ACB-30715FA44C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39212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7AEDF80-187A-35EF-10F1-D5BA69F0523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2F21A65-B9D9-22C4-2358-A9C5118AEC6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0A30A13-7E33-69AC-C78E-2BFACD119A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3F52E9-2FF6-4390-917F-0BA6DE85BBA2}" type="datetimeFigureOut">
              <a:rPr lang="en-US" smtClean="0"/>
              <a:t>3/2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C1810E1-7518-7A5E-689E-43E736987E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450D036-2EAE-2E90-247F-2FEAC1E619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E9AE9E-BD05-4698-9ACB-30715FA44C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30783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E80943E-87A0-FC6C-E086-13E1702058F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EA09E7B-5F48-8F86-BEA8-6C25DBA19E4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CF8D14F-A50B-D1CE-C97E-77332B596E5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10CCB52-E505-45FC-6AFD-0A7B5B7EFF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3F52E9-2FF6-4390-917F-0BA6DE85BBA2}" type="datetimeFigureOut">
              <a:rPr lang="en-US" smtClean="0"/>
              <a:t>3/24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34C88A3-A662-135C-F74B-01952C0529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1369CA2-EB0B-E655-4128-B94C8C8822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E9AE9E-BD05-4698-9ACB-30715FA44C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89198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194ED48-11CC-18A7-6B93-A8BCCB207A9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E2244FD-0985-A9FD-5C94-5094F6DD68F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857895C-8902-4BFB-8C32-A454892E23D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46F6475-1235-3702-78BB-D0D904616F0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73E682A-B87B-F565-372B-7FA5F980622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06EE360-1592-6103-7598-0DB8BE7062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3F52E9-2FF6-4390-917F-0BA6DE85BBA2}" type="datetimeFigureOut">
              <a:rPr lang="en-US" smtClean="0"/>
              <a:t>3/24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2E51E3C-6F36-03B6-6785-5BE2A9C9CF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51A3EE1-D6CA-BDB0-263B-F4C6EB712B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E9AE9E-BD05-4698-9ACB-30715FA44C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72150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A5D29DE-C511-9C24-D544-184AD85F810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CEFA0C8-8EAB-D991-30A1-ED19C7C587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3F52E9-2FF6-4390-917F-0BA6DE85BBA2}" type="datetimeFigureOut">
              <a:rPr lang="en-US" smtClean="0"/>
              <a:t>3/24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3D83BD8-99CA-A85D-D814-FBA2A8A032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F37159A-C6A4-EEFE-E14B-B31C925AAC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E9AE9E-BD05-4698-9ACB-30715FA44C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97722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70EABFA-DF6F-0658-12AA-825646334C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3F52E9-2FF6-4390-917F-0BA6DE85BBA2}" type="datetimeFigureOut">
              <a:rPr lang="en-US" smtClean="0"/>
              <a:t>3/24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5371D9E-6D54-2E25-5CFB-FC0D24A4D6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8601894-A88D-F7F6-1C9B-394C90CA8F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E9AE9E-BD05-4698-9ACB-30715FA44C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38045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089F9C5-8B6A-E054-3FBC-7115AAF3767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D62972C-1531-4B89-AF39-8D5B2113BA2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CD72CA1-AE8F-CEB4-CBFE-E61997C9A90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FC80CBB-97F3-ED24-836B-B41D6872F5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3F52E9-2FF6-4390-917F-0BA6DE85BBA2}" type="datetimeFigureOut">
              <a:rPr lang="en-US" smtClean="0"/>
              <a:t>3/24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40D1077-DE57-FFBC-B131-22B8FA870E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8B9E91F-AA1B-CB99-2F79-2EB30515ED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E9AE9E-BD05-4698-9ACB-30715FA44C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55806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28160CE-D25D-E4BB-D6B4-885E88191D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354C492-8A07-7F70-19DE-6A61A3449B4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253D6CD-2064-8097-CCDE-42AE39C76E0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72EDDA6-9D79-3E24-4B1C-A6FE060F74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3F52E9-2FF6-4390-917F-0BA6DE85BBA2}" type="datetimeFigureOut">
              <a:rPr lang="en-US" smtClean="0"/>
              <a:t>3/24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B9F77C0-1B8F-F21F-B93D-5AE6C58E0D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A0D94B0-B820-C0A4-0439-6ED0A51DD7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E9AE9E-BD05-4698-9ACB-30715FA44C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96731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0671F62-8167-881D-0EF2-41BC4F1D057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407A50F-14A2-F707-186A-A54EC02C5E2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098AF86-E3EC-E529-8E91-141D9D74ED1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B3F52E9-2FF6-4390-917F-0BA6DE85BBA2}" type="datetimeFigureOut">
              <a:rPr lang="en-US" smtClean="0"/>
              <a:t>3/2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273BE8F-EE0F-6BA0-59E2-FDA13879093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95B963C-DD53-213F-5142-54B52E7CFDF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3E9AE9E-BD05-4698-9ACB-30715FA44C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49853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29D31223-C265-7402-4B97-E7D66561F72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7977" y="1688476"/>
            <a:ext cx="5582212" cy="3178099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BC32508F-EFC8-3D55-49D9-7BCC1853213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125493" y="1688476"/>
            <a:ext cx="5628968" cy="3184982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7BC5345D-DE6E-F00D-0DB8-68C5E167437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09718" y="4873458"/>
            <a:ext cx="4980038" cy="1012513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5E3A4DFB-EB08-21F8-F9B7-4773F014F27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125493" y="4845391"/>
            <a:ext cx="5256128" cy="1068646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0744C87E-9597-E49E-20C5-1E6E1FD53059}"/>
              </a:ext>
            </a:extLst>
          </p:cNvPr>
          <p:cNvSpPr txBox="1"/>
          <p:nvPr/>
        </p:nvSpPr>
        <p:spPr>
          <a:xfrm>
            <a:off x="411061" y="1325453"/>
            <a:ext cx="60853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A                                                                                                                         B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3672A7D5-E911-A152-B405-3ACBAC00E141}"/>
              </a:ext>
            </a:extLst>
          </p:cNvPr>
          <p:cNvSpPr txBox="1"/>
          <p:nvPr/>
        </p:nvSpPr>
        <p:spPr>
          <a:xfrm>
            <a:off x="276842" y="411057"/>
            <a:ext cx="25370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Supplementary Figure 1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8DE8F033-09F4-73D7-79BD-44722D9BF2F5}"/>
              </a:ext>
            </a:extLst>
          </p:cNvPr>
          <p:cNvSpPr txBox="1"/>
          <p:nvPr/>
        </p:nvSpPr>
        <p:spPr>
          <a:xfrm>
            <a:off x="641759" y="5859724"/>
            <a:ext cx="84176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*                           *                                                                                               *                              *                </a:t>
            </a:r>
          </a:p>
        </p:txBody>
      </p:sp>
    </p:spTree>
    <p:extLst>
      <p:ext uri="{BB962C8B-B14F-4D97-AF65-F5344CB8AC3E}">
        <p14:creationId xmlns:p14="http://schemas.microsoft.com/office/powerpoint/2010/main" val="144428041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763CE56-AEB7-5DFE-58A1-34E12F9226E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2800"/>
              <a:t>Figure Legend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FF6B0E7-6EF6-A44E-DA3D-92B4404DA23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r>
              <a:rPr lang="en-US" sz="180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Supplementary Figure 1. A. Cases with Abnormal Karyotype. B. Cases with Normal Karyotype </a:t>
            </a:r>
            <a:br>
              <a:rPr lang="en-US" sz="180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</a:br>
            <a:r>
              <a:rPr lang="en-US" sz="180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This stacked bar chart presents the frequency and classification of additional findings detected using OGM across various hematologic malignancies. The findings are categorized into four tiers based on clinical relevance: Tier 1 variants (shown in orange) are SVs or CNVs with established diagnostic, prognostic, or therapeutic relevance. Tier 2 variants (shown in blue)  have some clinical relevance but do not satisfy all the criteria for Tier 1. Tier 3 variants (shown in yellow) are acquired aberrations without a known link to neoplastic disorders. None (shown in green) indicated no additional aberrations. The x-axis lists different disease categories, including AML (acute myeloid leukemia), B-ALL (B-cell acute lymphoblastic leukemia), T-ALL (T-cell acute lymphoblastic leukemia), MPAL (mixed phenotype acute leukemia), MDS (myelodysplastic syndromes), MPN (myeloproliferative neoplasms), MDS/MPN (overlapping syndromes), CLL (chronic lymphocytic leukemia), MCL (mantle cell lymphoma), Other BCL (other B-cell lymphomas), MM (multiple myeloma), and T-cell lymphomas/T-PLL (T-prolymphocytic leukemia). The rightmost bar represents findings across all cases analyzed. Numerical values within the bars indicate the number of cases in each category. Asterix indicate statistical significance.</a:t>
            </a:r>
            <a:endParaRPr lang="en-US" sz="180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86929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50</Words>
  <Application>Microsoft Office PowerPoint</Application>
  <PresentationFormat>Widescreen</PresentationFormat>
  <Paragraphs>5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ptos</vt:lpstr>
      <vt:lpstr>Aptos Display</vt:lpstr>
      <vt:lpstr>Arial</vt:lpstr>
      <vt:lpstr>Times New Roman</vt:lpstr>
      <vt:lpstr>Office Theme</vt:lpstr>
      <vt:lpstr>PowerPoint Presentation</vt:lpstr>
      <vt:lpstr>Figure Legend</vt:lpstr>
    </vt:vector>
  </TitlesOfParts>
  <Company>M.D. Anderson Cancer Center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Toruner,Gokce Altay</dc:creator>
  <cp:lastModifiedBy>Toruner,Gokce Altay</cp:lastModifiedBy>
  <cp:revision>1</cp:revision>
  <dcterms:created xsi:type="dcterms:W3CDTF">2025-03-05T17:05:41Z</dcterms:created>
  <dcterms:modified xsi:type="dcterms:W3CDTF">2025-03-25T00:55:58Z</dcterms:modified>
</cp:coreProperties>
</file>